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65" r:id="rId3"/>
    <p:sldId id="266" r:id="rId4"/>
    <p:sldId id="267" r:id="rId5"/>
    <p:sldId id="257" r:id="rId6"/>
    <p:sldId id="286" r:id="rId7"/>
    <p:sldId id="287" r:id="rId8"/>
    <p:sldId id="288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228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D:\OneDrive\&#26700;&#38754;\&#35797;&#39564;&#35760;&#24405;\24%6011%6029-IWB12298&#65288;&#26367;&#25442;&#65289;.xlsx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Sheet4!$B$2:$B$367</cx:f>
        <cx:lvl ptCount="276">
          <cx:pt idx="0">IWB12298+</cx:pt>
          <cx:pt idx="1">IWB12298+</cx:pt>
          <cx:pt idx="2">IWB12298+</cx:pt>
          <cx:pt idx="3">IWB12298+</cx:pt>
          <cx:pt idx="4">IWB12298+</cx:pt>
          <cx:pt idx="5">IWB12298+</cx:pt>
          <cx:pt idx="6">IWB12298+</cx:pt>
          <cx:pt idx="7">IWB12298-</cx:pt>
          <cx:pt idx="8">IWB12298+</cx:pt>
          <cx:pt idx="9">IWB12298+</cx:pt>
          <cx:pt idx="10">IWB12298+</cx:pt>
          <cx:pt idx="11">IWB12298+</cx:pt>
          <cx:pt idx="12">IWB12298-</cx:pt>
          <cx:pt idx="13">IWB12298+</cx:pt>
          <cx:pt idx="14">IWB12298+</cx:pt>
          <cx:pt idx="15">IWB12298+</cx:pt>
          <cx:pt idx="16">IWB12298-</cx:pt>
          <cx:pt idx="17">IWB12298-</cx:pt>
          <cx:pt idx="18">IWB12298+</cx:pt>
          <cx:pt idx="19">IWB12298+</cx:pt>
          <cx:pt idx="20">IWB12298-</cx:pt>
          <cx:pt idx="21">IWB12298-</cx:pt>
          <cx:pt idx="22">IWB12298+</cx:pt>
          <cx:pt idx="23">IWB12298+</cx:pt>
          <cx:pt idx="24">IWB12298-</cx:pt>
          <cx:pt idx="25">IWB12298+</cx:pt>
          <cx:pt idx="26">IWB12298+</cx:pt>
          <cx:pt idx="27">IWB12298+</cx:pt>
          <cx:pt idx="28">IWB12298+</cx:pt>
          <cx:pt idx="29">IWB12298+</cx:pt>
          <cx:pt idx="30">IWB12298+</cx:pt>
          <cx:pt idx="31">IWB12298+</cx:pt>
          <cx:pt idx="32">IWB12298+</cx:pt>
          <cx:pt idx="33">IWB12298+</cx:pt>
          <cx:pt idx="34">IWB12298+</cx:pt>
          <cx:pt idx="35">IWB12298+</cx:pt>
          <cx:pt idx="36">IWB12298+</cx:pt>
          <cx:pt idx="37">IWB12298+</cx:pt>
          <cx:pt idx="38">IWB12298+</cx:pt>
          <cx:pt idx="39">IWB12298-</cx:pt>
          <cx:pt idx="40">IWB12298+</cx:pt>
          <cx:pt idx="41">IWB12298+</cx:pt>
          <cx:pt idx="42">IWB12298+</cx:pt>
          <cx:pt idx="43">IWB12298+</cx:pt>
          <cx:pt idx="44">IWB12298+</cx:pt>
          <cx:pt idx="45">IWB12298+</cx:pt>
          <cx:pt idx="46">IWB12298+</cx:pt>
          <cx:pt idx="47">IWB12298+</cx:pt>
          <cx:pt idx="48">IWB12298+</cx:pt>
          <cx:pt idx="49">IWB12298+</cx:pt>
          <cx:pt idx="50">IWB12298+</cx:pt>
          <cx:pt idx="51">IWB12298+</cx:pt>
          <cx:pt idx="52">IWB12298+</cx:pt>
          <cx:pt idx="53">IWB12298+</cx:pt>
          <cx:pt idx="54">IWB12298+</cx:pt>
          <cx:pt idx="55">IWB12298+</cx:pt>
          <cx:pt idx="56">IWB12298+</cx:pt>
          <cx:pt idx="57">IWB12298-</cx:pt>
          <cx:pt idx="58">IWB12298-</cx:pt>
          <cx:pt idx="59">IWB12298+</cx:pt>
          <cx:pt idx="60">IWB12298+</cx:pt>
          <cx:pt idx="61">IWB12298+</cx:pt>
          <cx:pt idx="62">IWB12298+</cx:pt>
          <cx:pt idx="63">IWB12298-</cx:pt>
          <cx:pt idx="64">IWB12298+</cx:pt>
          <cx:pt idx="65">IWB12298-</cx:pt>
          <cx:pt idx="66">IWB12298+</cx:pt>
          <cx:pt idx="67">IWB12298+</cx:pt>
          <cx:pt idx="68">IWB12298+</cx:pt>
          <cx:pt idx="69">IWB12298+</cx:pt>
          <cx:pt idx="70">IWB12298-</cx:pt>
          <cx:pt idx="71">IWB12298-</cx:pt>
          <cx:pt idx="72">IWB12298+</cx:pt>
          <cx:pt idx="73">IWB12298+</cx:pt>
          <cx:pt idx="74">IWB12298+</cx:pt>
          <cx:pt idx="75">IWB12298+</cx:pt>
          <cx:pt idx="76">IWB12298+</cx:pt>
          <cx:pt idx="77">IWB12298+</cx:pt>
          <cx:pt idx="78">IWB12298+</cx:pt>
          <cx:pt idx="79">IWB12298+</cx:pt>
          <cx:pt idx="80">IWB12298-</cx:pt>
          <cx:pt idx="81">IWB12298+</cx:pt>
          <cx:pt idx="82">IWB12298+</cx:pt>
          <cx:pt idx="83">IWB12298-</cx:pt>
          <cx:pt idx="84">IWB12298+</cx:pt>
          <cx:pt idx="85">IWB12298+</cx:pt>
          <cx:pt idx="86">IWB12298+</cx:pt>
          <cx:pt idx="87">IWB12298+</cx:pt>
          <cx:pt idx="88">IWB12298-</cx:pt>
          <cx:pt idx="89">IWB12298+</cx:pt>
          <cx:pt idx="90">IWB12298-</cx:pt>
          <cx:pt idx="91">IWB12298+</cx:pt>
          <cx:pt idx="92">IWB12298+</cx:pt>
          <cx:pt idx="93">IWB12298+</cx:pt>
          <cx:pt idx="94">IWB12298+</cx:pt>
          <cx:pt idx="95">IWB12298-</cx:pt>
          <cx:pt idx="96">IWB12298+</cx:pt>
          <cx:pt idx="97">IWB12298+</cx:pt>
          <cx:pt idx="98">IWB12298+</cx:pt>
          <cx:pt idx="99">IWB12298+</cx:pt>
          <cx:pt idx="100">IWB12298+</cx:pt>
          <cx:pt idx="101">IWB12298+</cx:pt>
          <cx:pt idx="102">IWB12298-</cx:pt>
          <cx:pt idx="103">IWB12298+</cx:pt>
          <cx:pt idx="104">IWB12298+</cx:pt>
          <cx:pt idx="105">IWB12298-</cx:pt>
          <cx:pt idx="106">IWB12298+</cx:pt>
          <cx:pt idx="107">IWB12298+</cx:pt>
          <cx:pt idx="108">IWB12298+</cx:pt>
          <cx:pt idx="109">IWB12298+</cx:pt>
          <cx:pt idx="110">IWB12298+</cx:pt>
          <cx:pt idx="111">IWB12298+</cx:pt>
          <cx:pt idx="112">IWB12298+</cx:pt>
          <cx:pt idx="113">IWB12298+</cx:pt>
          <cx:pt idx="114">IWB12298-</cx:pt>
          <cx:pt idx="115">IWB12298-</cx:pt>
          <cx:pt idx="116">IWB12298+</cx:pt>
          <cx:pt idx="117">IWB12298+</cx:pt>
          <cx:pt idx="118">IWB12298+</cx:pt>
          <cx:pt idx="119">IWB12298+</cx:pt>
          <cx:pt idx="120">IWB12298+</cx:pt>
          <cx:pt idx="121">IWB12298+</cx:pt>
          <cx:pt idx="122">IWB12298-</cx:pt>
          <cx:pt idx="123">IWB12298+</cx:pt>
          <cx:pt idx="124">IWB12298-</cx:pt>
          <cx:pt idx="125">IWB12298-</cx:pt>
          <cx:pt idx="126">IWB12298-</cx:pt>
          <cx:pt idx="127">IWB12298-</cx:pt>
          <cx:pt idx="128">IWB12298+</cx:pt>
          <cx:pt idx="129">IWB12298-</cx:pt>
          <cx:pt idx="130">IWB12298+</cx:pt>
          <cx:pt idx="131">IWB12298+</cx:pt>
          <cx:pt idx="132">IWB12298-</cx:pt>
          <cx:pt idx="133">IWB12298-</cx:pt>
          <cx:pt idx="134">IWB12298-</cx:pt>
          <cx:pt idx="135">IWB12298+</cx:pt>
          <cx:pt idx="136">IWB12298+</cx:pt>
          <cx:pt idx="137">IWB12298-</cx:pt>
          <cx:pt idx="138">IWB12298+</cx:pt>
          <cx:pt idx="139">IWB12298+</cx:pt>
          <cx:pt idx="140">IWB12298+</cx:pt>
          <cx:pt idx="141">IWB12298+</cx:pt>
          <cx:pt idx="142">IWB12298+</cx:pt>
          <cx:pt idx="143">IWB12298+</cx:pt>
          <cx:pt idx="144">IWB12298+</cx:pt>
          <cx:pt idx="145">IWB12298-</cx:pt>
          <cx:pt idx="146">IWB12298+</cx:pt>
          <cx:pt idx="147">IWB12298+</cx:pt>
          <cx:pt idx="148">IWB12298+</cx:pt>
          <cx:pt idx="149">IWB12298+</cx:pt>
          <cx:pt idx="150">IWB12298+</cx:pt>
          <cx:pt idx="151">IWB12298+</cx:pt>
          <cx:pt idx="152">IWB12298+</cx:pt>
          <cx:pt idx="153">IWB12298+</cx:pt>
          <cx:pt idx="154">IWB12298+</cx:pt>
          <cx:pt idx="155">IWB12298+</cx:pt>
          <cx:pt idx="156">IWB12298+</cx:pt>
          <cx:pt idx="157">IWB12298+</cx:pt>
          <cx:pt idx="158">IWB12298+</cx:pt>
          <cx:pt idx="159">IWB12298+</cx:pt>
          <cx:pt idx="160">IWB12298+</cx:pt>
          <cx:pt idx="161">IWB12298+</cx:pt>
          <cx:pt idx="162">IWB12298+</cx:pt>
          <cx:pt idx="163">IWB12298+</cx:pt>
          <cx:pt idx="164">IWB12298+</cx:pt>
          <cx:pt idx="165">IWB12298+</cx:pt>
          <cx:pt idx="166">IWB12298+</cx:pt>
          <cx:pt idx="167">IWB12298+</cx:pt>
          <cx:pt idx="168">IWB12298+</cx:pt>
          <cx:pt idx="169">IWB12298+</cx:pt>
          <cx:pt idx="170">IWB12298+</cx:pt>
          <cx:pt idx="171">IWB12298+</cx:pt>
          <cx:pt idx="172">IWB12298+</cx:pt>
          <cx:pt idx="173">IWB12298+</cx:pt>
          <cx:pt idx="174">IWB12298+</cx:pt>
          <cx:pt idx="175">IWB12298+</cx:pt>
          <cx:pt idx="176">IWB12298+</cx:pt>
          <cx:pt idx="177">IWB12298+</cx:pt>
          <cx:pt idx="178">IWB12298+</cx:pt>
          <cx:pt idx="179">IWB12298+</cx:pt>
          <cx:pt idx="180">IWB12298+</cx:pt>
          <cx:pt idx="181">IWB12298+</cx:pt>
          <cx:pt idx="182">IWB12298+</cx:pt>
          <cx:pt idx="183">IWB12298+</cx:pt>
          <cx:pt idx="184">IWB12298+</cx:pt>
          <cx:pt idx="185">IWB12298+</cx:pt>
          <cx:pt idx="186">IWB12298+</cx:pt>
          <cx:pt idx="187">IWB12298+</cx:pt>
          <cx:pt idx="188">IWB12298+</cx:pt>
          <cx:pt idx="189">IWB12298+</cx:pt>
          <cx:pt idx="190">IWB12298+</cx:pt>
          <cx:pt idx="191">IWB12298+</cx:pt>
          <cx:pt idx="192">IWB12298+</cx:pt>
          <cx:pt idx="193">IWB12298+</cx:pt>
          <cx:pt idx="194">IWB12298-</cx:pt>
          <cx:pt idx="195">IWB12298+</cx:pt>
          <cx:pt idx="196">IWB12298+</cx:pt>
          <cx:pt idx="197">IWB12298+</cx:pt>
          <cx:pt idx="198">IWB12298+</cx:pt>
          <cx:pt idx="199">IWB12298+</cx:pt>
          <cx:pt idx="200">IWB12298+</cx:pt>
          <cx:pt idx="201">IWB12298+</cx:pt>
          <cx:pt idx="202">IWB12298+</cx:pt>
          <cx:pt idx="203">IWB12298+</cx:pt>
          <cx:pt idx="204">IWB12298+</cx:pt>
          <cx:pt idx="205">IWB12298+</cx:pt>
          <cx:pt idx="206">IWB12298+</cx:pt>
          <cx:pt idx="207">IWB12298+</cx:pt>
          <cx:pt idx="208">IWB12298+</cx:pt>
          <cx:pt idx="209">IWB12298+</cx:pt>
          <cx:pt idx="210">IWB12298+</cx:pt>
          <cx:pt idx="211">IWB12298+</cx:pt>
          <cx:pt idx="212">IWB12298+</cx:pt>
          <cx:pt idx="213">IWB12298+</cx:pt>
          <cx:pt idx="214">IWB12298+</cx:pt>
          <cx:pt idx="215">IWB12298+</cx:pt>
          <cx:pt idx="216">IWB12298-</cx:pt>
          <cx:pt idx="217">IWB12298+</cx:pt>
          <cx:pt idx="218">IWB12298+</cx:pt>
          <cx:pt idx="219">IWB12298+</cx:pt>
          <cx:pt idx="220">IWB12298-</cx:pt>
          <cx:pt idx="221">IWB12298-</cx:pt>
          <cx:pt idx="222">IWB12298+</cx:pt>
          <cx:pt idx="223">IWB12298+</cx:pt>
          <cx:pt idx="224">IWB12298+</cx:pt>
          <cx:pt idx="225">IWB12298+</cx:pt>
          <cx:pt idx="226">IWB12298+</cx:pt>
          <cx:pt idx="227">IWB12298+</cx:pt>
          <cx:pt idx="228">IWB12298+</cx:pt>
          <cx:pt idx="229">IWB12298-</cx:pt>
          <cx:pt idx="230">IWB12298+</cx:pt>
          <cx:pt idx="231">IWB12298-</cx:pt>
          <cx:pt idx="232">IWB12298+</cx:pt>
          <cx:pt idx="233">IWB12298-</cx:pt>
          <cx:pt idx="234">IWB12298+</cx:pt>
          <cx:pt idx="235">IWB12298-</cx:pt>
          <cx:pt idx="236">IWB12298+</cx:pt>
          <cx:pt idx="237">IWB12298-</cx:pt>
          <cx:pt idx="238">IWB12298+</cx:pt>
          <cx:pt idx="239">IWB12298+</cx:pt>
          <cx:pt idx="240">IWB12298+</cx:pt>
          <cx:pt idx="241">IWB12298-</cx:pt>
          <cx:pt idx="242">IWB12298+</cx:pt>
          <cx:pt idx="243">IWB12298+</cx:pt>
          <cx:pt idx="244">IWB12298-</cx:pt>
          <cx:pt idx="245">IWB12298-</cx:pt>
          <cx:pt idx="246">IWB12298-</cx:pt>
          <cx:pt idx="247">IWB12298-</cx:pt>
          <cx:pt idx="248">IWB12298+</cx:pt>
          <cx:pt idx="249">IWB12298+</cx:pt>
          <cx:pt idx="250">IWB12298+</cx:pt>
          <cx:pt idx="251">IWB12298-</cx:pt>
          <cx:pt idx="252">IWB12298+</cx:pt>
          <cx:pt idx="253">IWB12298+</cx:pt>
          <cx:pt idx="254">IWB12298+</cx:pt>
          <cx:pt idx="255">IWB12298+</cx:pt>
          <cx:pt idx="256">IWB12298+</cx:pt>
          <cx:pt idx="257">IWB12298+</cx:pt>
          <cx:pt idx="258">IWB12298+</cx:pt>
          <cx:pt idx="259">IWB12298+</cx:pt>
          <cx:pt idx="260">IWB12298+</cx:pt>
          <cx:pt idx="261">IWB12298+</cx:pt>
          <cx:pt idx="262">IWB12298+</cx:pt>
          <cx:pt idx="263">IWB12298+</cx:pt>
          <cx:pt idx="264">IWB12298+</cx:pt>
          <cx:pt idx="265">IWB12298+</cx:pt>
          <cx:pt idx="266">IWB12298+</cx:pt>
          <cx:pt idx="267">IWB12298+</cx:pt>
          <cx:pt idx="268">IWB12298+</cx:pt>
          <cx:pt idx="269">IWB12298+</cx:pt>
          <cx:pt idx="270">IWB12298+</cx:pt>
          <cx:pt idx="271">IWB12298+</cx:pt>
          <cx:pt idx="272">IWB12298+</cx:pt>
          <cx:pt idx="273">IWB12298+</cx:pt>
          <cx:pt idx="274">IWB12298+</cx:pt>
          <cx:pt idx="275">IWB12298+</cx:pt>
        </cx:lvl>
      </cx:strDim>
      <cx:numDim type="val">
        <cx:f>Sheet4!$C$2:$C$367</cx:f>
        <cx:lvl ptCount="276" formatCode="G/通用格式">
          <cx:pt idx="0">70</cx:pt>
          <cx:pt idx="1">10</cx:pt>
          <cx:pt idx="2">80</cx:pt>
          <cx:pt idx="3">60</cx:pt>
          <cx:pt idx="4">30</cx:pt>
          <cx:pt idx="5">40</cx:pt>
          <cx:pt idx="6">50</cx:pt>
          <cx:pt idx="7">40</cx:pt>
          <cx:pt idx="8">40</cx:pt>
          <cx:pt idx="9">50</cx:pt>
          <cx:pt idx="10">30</cx:pt>
          <cx:pt idx="11">40</cx:pt>
          <cx:pt idx="12">70</cx:pt>
          <cx:pt idx="13">40</cx:pt>
          <cx:pt idx="14">90</cx:pt>
          <cx:pt idx="15">30</cx:pt>
          <cx:pt idx="16">80</cx:pt>
          <cx:pt idx="17">70</cx:pt>
          <cx:pt idx="18">40</cx:pt>
          <cx:pt idx="19">0</cx:pt>
          <cx:pt idx="20">10</cx:pt>
          <cx:pt idx="21">90</cx:pt>
          <cx:pt idx="22">40</cx:pt>
          <cx:pt idx="23">0</cx:pt>
          <cx:pt idx="24">0</cx:pt>
          <cx:pt idx="25">80</cx:pt>
          <cx:pt idx="26">90</cx:pt>
          <cx:pt idx="27">0</cx:pt>
          <cx:pt idx="28">80</cx:pt>
          <cx:pt idx="29">30</cx:pt>
          <cx:pt idx="30">80</cx:pt>
          <cx:pt idx="31">80</cx:pt>
          <cx:pt idx="32">60</cx:pt>
          <cx:pt idx="33">20</cx:pt>
          <cx:pt idx="34">40</cx:pt>
          <cx:pt idx="35">70</cx:pt>
          <cx:pt idx="36">90</cx:pt>
          <cx:pt idx="37">20</cx:pt>
          <cx:pt idx="38">50</cx:pt>
          <cx:pt idx="39">30</cx:pt>
          <cx:pt idx="40">70</cx:pt>
          <cx:pt idx="41">40</cx:pt>
          <cx:pt idx="42">30</cx:pt>
          <cx:pt idx="43">20</cx:pt>
          <cx:pt idx="44">30</cx:pt>
          <cx:pt idx="45">40</cx:pt>
          <cx:pt idx="46">60</cx:pt>
          <cx:pt idx="47">90</cx:pt>
          <cx:pt idx="48">90</cx:pt>
          <cx:pt idx="49">30</cx:pt>
          <cx:pt idx="50">10</cx:pt>
          <cx:pt idx="51">70</cx:pt>
          <cx:pt idx="52">80</cx:pt>
          <cx:pt idx="53">60</cx:pt>
          <cx:pt idx="54">80</cx:pt>
          <cx:pt idx="55">70</cx:pt>
          <cx:pt idx="56">60</cx:pt>
          <cx:pt idx="57">80</cx:pt>
          <cx:pt idx="58">50</cx:pt>
          <cx:pt idx="59">80</cx:pt>
          <cx:pt idx="60">40</cx:pt>
          <cx:pt idx="61">90</cx:pt>
          <cx:pt idx="62">70</cx:pt>
          <cx:pt idx="63">60</cx:pt>
          <cx:pt idx="64">40</cx:pt>
          <cx:pt idx="65">70</cx:pt>
          <cx:pt idx="66">40</cx:pt>
          <cx:pt idx="67">60</cx:pt>
          <cx:pt idx="68">40</cx:pt>
          <cx:pt idx="69">40</cx:pt>
          <cx:pt idx="70">90</cx:pt>
          <cx:pt idx="71">35</cx:pt>
          <cx:pt idx="72">40</cx:pt>
          <cx:pt idx="73">80</cx:pt>
          <cx:pt idx="74">70</cx:pt>
          <cx:pt idx="75">30</cx:pt>
          <cx:pt idx="76">70</cx:pt>
          <cx:pt idx="77">40</cx:pt>
          <cx:pt idx="78">40</cx:pt>
          <cx:pt idx="79">40</cx:pt>
          <cx:pt idx="80">90</cx:pt>
          <cx:pt idx="81">80</cx:pt>
          <cx:pt idx="82">30</cx:pt>
          <cx:pt idx="83">40</cx:pt>
          <cx:pt idx="84">70</cx:pt>
          <cx:pt idx="85">80</cx:pt>
          <cx:pt idx="86">40</cx:pt>
          <cx:pt idx="87">70</cx:pt>
          <cx:pt idx="88">90</cx:pt>
          <cx:pt idx="89">90</cx:pt>
          <cx:pt idx="90">50</cx:pt>
          <cx:pt idx="91">35</cx:pt>
          <cx:pt idx="92">80</cx:pt>
          <cx:pt idx="93">40</cx:pt>
          <cx:pt idx="94">30</cx:pt>
          <cx:pt idx="95">100</cx:pt>
          <cx:pt idx="96">90</cx:pt>
          <cx:pt idx="97">40</cx:pt>
          <cx:pt idx="98">40</cx:pt>
          <cx:pt idx="99">80</cx:pt>
          <cx:pt idx="100">50</cx:pt>
          <cx:pt idx="101">50</cx:pt>
          <cx:pt idx="102">80</cx:pt>
          <cx:pt idx="103">70</cx:pt>
          <cx:pt idx="104">50</cx:pt>
          <cx:pt idx="105">70</cx:pt>
          <cx:pt idx="106">40</cx:pt>
          <cx:pt idx="107">60</cx:pt>
          <cx:pt idx="108">80</cx:pt>
          <cx:pt idx="109">70</cx:pt>
          <cx:pt idx="110">90</cx:pt>
          <cx:pt idx="111">90</cx:pt>
          <cx:pt idx="112">50</cx:pt>
          <cx:pt idx="113">40</cx:pt>
          <cx:pt idx="114">70</cx:pt>
          <cx:pt idx="115">90</cx:pt>
          <cx:pt idx="116">80</cx:pt>
          <cx:pt idx="117">90</cx:pt>
          <cx:pt idx="118">90</cx:pt>
          <cx:pt idx="119">90</cx:pt>
          <cx:pt idx="120">80</cx:pt>
          <cx:pt idx="121">30</cx:pt>
          <cx:pt idx="122">80</cx:pt>
          <cx:pt idx="123">100</cx:pt>
          <cx:pt idx="124">80</cx:pt>
          <cx:pt idx="125">70</cx:pt>
          <cx:pt idx="126">20</cx:pt>
          <cx:pt idx="127">80</cx:pt>
          <cx:pt idx="128">60</cx:pt>
          <cx:pt idx="129">90</cx:pt>
          <cx:pt idx="130">100</cx:pt>
          <cx:pt idx="131">50</cx:pt>
          <cx:pt idx="132">70</cx:pt>
          <cx:pt idx="133">90</cx:pt>
          <cx:pt idx="134">90</cx:pt>
          <cx:pt idx="135">60</cx:pt>
          <cx:pt idx="136">70</cx:pt>
          <cx:pt idx="137">40</cx:pt>
          <cx:pt idx="138">80</cx:pt>
          <cx:pt idx="139">40</cx:pt>
          <cx:pt idx="140">50</cx:pt>
          <cx:pt idx="141">60</cx:pt>
          <cx:pt idx="142">70</cx:pt>
          <cx:pt idx="143">80</cx:pt>
          <cx:pt idx="144">70</cx:pt>
          <cx:pt idx="145">80</cx:pt>
          <cx:pt idx="146">90</cx:pt>
          <cx:pt idx="147">40</cx:pt>
          <cx:pt idx="148">90</cx:pt>
          <cx:pt idx="149">80</cx:pt>
          <cx:pt idx="150">50</cx:pt>
          <cx:pt idx="151">80</cx:pt>
          <cx:pt idx="152">40</cx:pt>
          <cx:pt idx="153">60</cx:pt>
          <cx:pt idx="154">90</cx:pt>
          <cx:pt idx="155">90</cx:pt>
          <cx:pt idx="156">40</cx:pt>
          <cx:pt idx="157">80</cx:pt>
          <cx:pt idx="158">60</cx:pt>
          <cx:pt idx="159">70</cx:pt>
          <cx:pt idx="160">40</cx:pt>
          <cx:pt idx="161">60</cx:pt>
          <cx:pt idx="162">80</cx:pt>
          <cx:pt idx="163">50</cx:pt>
          <cx:pt idx="164">70</cx:pt>
          <cx:pt idx="165">80</cx:pt>
          <cx:pt idx="166">60</cx:pt>
          <cx:pt idx="167">80</cx:pt>
          <cx:pt idx="168">90</cx:pt>
          <cx:pt idx="169">40</cx:pt>
          <cx:pt idx="170">60</cx:pt>
          <cx:pt idx="171">50</cx:pt>
          <cx:pt idx="172">80</cx:pt>
          <cx:pt idx="173">40</cx:pt>
          <cx:pt idx="174">30</cx:pt>
          <cx:pt idx="175">60</cx:pt>
          <cx:pt idx="176">80</cx:pt>
          <cx:pt idx="177">30</cx:pt>
          <cx:pt idx="178">20</cx:pt>
          <cx:pt idx="179">50</cx:pt>
          <cx:pt idx="180">70</cx:pt>
          <cx:pt idx="181">40</cx:pt>
          <cx:pt idx="182">20</cx:pt>
          <cx:pt idx="183">20</cx:pt>
          <cx:pt idx="184">50</cx:pt>
          <cx:pt idx="185">20</cx:pt>
          <cx:pt idx="186">40</cx:pt>
          <cx:pt idx="187">10</cx:pt>
          <cx:pt idx="188">80</cx:pt>
          <cx:pt idx="189">10</cx:pt>
          <cx:pt idx="190">40</cx:pt>
          <cx:pt idx="191">20</cx:pt>
          <cx:pt idx="192">20</cx:pt>
          <cx:pt idx="193">80</cx:pt>
          <cx:pt idx="194">90</cx:pt>
          <cx:pt idx="195">10</cx:pt>
          <cx:pt idx="196">80</cx:pt>
          <cx:pt idx="197">50</cx:pt>
          <cx:pt idx="198">60</cx:pt>
          <cx:pt idx="199">80</cx:pt>
          <cx:pt idx="200">50</cx:pt>
          <cx:pt idx="201">40</cx:pt>
          <cx:pt idx="202">20</cx:pt>
          <cx:pt idx="203">60</cx:pt>
          <cx:pt idx="204">40</cx:pt>
          <cx:pt idx="205">80</cx:pt>
          <cx:pt idx="206">30</cx:pt>
          <cx:pt idx="207">20</cx:pt>
          <cx:pt idx="208">80</cx:pt>
          <cx:pt idx="209">30</cx:pt>
          <cx:pt idx="210">30</cx:pt>
          <cx:pt idx="211">50</cx:pt>
          <cx:pt idx="212">60</cx:pt>
          <cx:pt idx="213">70</cx:pt>
          <cx:pt idx="214">90</cx:pt>
          <cx:pt idx="215">80</cx:pt>
          <cx:pt idx="216">50</cx:pt>
          <cx:pt idx="217">40</cx:pt>
          <cx:pt idx="218">40</cx:pt>
          <cx:pt idx="219">50</cx:pt>
          <cx:pt idx="220">70</cx:pt>
          <cx:pt idx="221">90</cx:pt>
          <cx:pt idx="222">10</cx:pt>
          <cx:pt idx="223">10</cx:pt>
          <cx:pt idx="224">10</cx:pt>
          <cx:pt idx="225">80</cx:pt>
          <cx:pt idx="226">80</cx:pt>
          <cx:pt idx="227">80</cx:pt>
          <cx:pt idx="228">50</cx:pt>
          <cx:pt idx="229">100</cx:pt>
          <cx:pt idx="230">90</cx:pt>
          <cx:pt idx="231">90</cx:pt>
          <cx:pt idx="232">60</cx:pt>
          <cx:pt idx="233">80</cx:pt>
          <cx:pt idx="234">80</cx:pt>
          <cx:pt idx="235">50</cx:pt>
          <cx:pt idx="236">50</cx:pt>
          <cx:pt idx="237">80</cx:pt>
          <cx:pt idx="238">70</cx:pt>
          <cx:pt idx="239">70</cx:pt>
          <cx:pt idx="240">50</cx:pt>
          <cx:pt idx="241">40</cx:pt>
          <cx:pt idx="242">70</cx:pt>
          <cx:pt idx="243">100</cx:pt>
          <cx:pt idx="244">80</cx:pt>
          <cx:pt idx="245">90</cx:pt>
          <cx:pt idx="246">90</cx:pt>
          <cx:pt idx="247">100</cx:pt>
          <cx:pt idx="248">70</cx:pt>
          <cx:pt idx="249">100</cx:pt>
          <cx:pt idx="250">70</cx:pt>
          <cx:pt idx="251">100</cx:pt>
          <cx:pt idx="252">80</cx:pt>
          <cx:pt idx="253">50</cx:pt>
          <cx:pt idx="254">80</cx:pt>
          <cx:pt idx="255">5</cx:pt>
          <cx:pt idx="256">10</cx:pt>
          <cx:pt idx="257">10</cx:pt>
          <cx:pt idx="258">10</cx:pt>
          <cx:pt idx="259">10</cx:pt>
          <cx:pt idx="260">20</cx:pt>
          <cx:pt idx="261">10</cx:pt>
          <cx:pt idx="262">5</cx:pt>
          <cx:pt idx="263">10</cx:pt>
          <cx:pt idx="264">20</cx:pt>
          <cx:pt idx="265">10</cx:pt>
          <cx:pt idx="266">10</cx:pt>
          <cx:pt idx="267">10</cx:pt>
          <cx:pt idx="268">30</cx:pt>
          <cx:pt idx="269">5</cx:pt>
          <cx:pt idx="270">10</cx:pt>
          <cx:pt idx="271">10</cx:pt>
          <cx:pt idx="272">20</cx:pt>
          <cx:pt idx="273">5</cx:pt>
          <cx:pt idx="274">5</cx:pt>
          <cx:pt idx="275">10</cx:pt>
        </cx:lvl>
      </cx:numDim>
    </cx:data>
  </cx:chartData>
  <cx:chart>
    <cx:plotArea>
      <cx:plotAreaRegion>
        <cx:series layoutId="boxWhisker" uniqueId="{D7EC351F-E012-489D-ABD7-2F8C07D82ED9}" formatIdx="1">
          <cx:tx>
            <cx:txData>
              <cx:f>Sheet4!$C$1</cx:f>
              <cx:v>DS2</cx:v>
            </cx:txData>
          </cx:tx>
          <cx:spPr>
            <a:solidFill>
              <a:schemeClr val="bg2">
                <a:lumMod val="75000"/>
              </a:schemeClr>
            </a:solidFill>
            <a:ln w="12700" cap="flat" cmpd="sng" algn="ctr">
              <a:solidFill>
                <a:schemeClr val="dk1"/>
              </a:solidFill>
              <a:prstDash val="solid"/>
              <a:miter lim="800000"/>
            </a:ln>
            <a:effectLst/>
          </cx:spPr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majorTickMarks type="out"/>
        <cx:tickLabels/>
        <cx:spPr>
          <a:ln w="12700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050" i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 altLang="en-US" sz="1050" b="0" i="1" u="none" strike="noStrike" baseline="0">
              <a:solidFill>
                <a:schemeClr val="tx1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cx:txPr>
      </cx:axis>
      <cx:axis id="1">
        <cx:valScaling max="100"/>
        <cx:majorTickMarks type="out"/>
        <cx:tickLabels/>
        <cx:spPr>
          <a:ln w="12700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defRPr>
            </a:pPr>
            <a:endParaRPr lang="zh-CN" altLang="en-US" sz="900" b="0" i="0" u="none" strike="noStrike" baseline="0">
              <a:solidFill>
                <a:schemeClr val="tx1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65C117-F016-46F1-9583-7880E64E1E59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91F23B-D382-461C-997D-119821DB97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88767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1 The physical location of </a:t>
            </a:r>
            <a:r>
              <a:rPr lang="en-US" altLang="zh-CN" sz="18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QYrxz.nwafu-2BL.5</a:t>
            </a:r>
            <a:r>
              <a:rPr lang="en-US" altLang="zh-CN" sz="1800" b="1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nd reported genes/QTL that marked in red and blue, respectively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91F23B-D382-461C-997D-119821DB979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40611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2 </a:t>
            </a:r>
            <a:r>
              <a:rPr lang="zh-CN" altLang="en-US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dirty="0"/>
              <a:t>Changes in the amino acid sequence encoded in the </a:t>
            </a:r>
            <a:r>
              <a:rPr lang="en-US" altLang="zh-CN" i="1" dirty="0"/>
              <a:t>Yr9</a:t>
            </a:r>
            <a:r>
              <a:rPr lang="en-US" altLang="zh-CN" dirty="0"/>
              <a:t> susceptible mutant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tps://www.novopro.cn/tools/muscle.htm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91F23B-D382-461C-997D-119821DB9798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80967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tps://www.novopro.cn/tools/muscle.html</a:t>
            </a: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91F23B-D382-461C-997D-119821DB9798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90391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3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zh-CN" altLang="en-US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dirty="0"/>
              <a:t>The amplification of </a:t>
            </a:r>
            <a:r>
              <a:rPr lang="en-US" altLang="zh-CN" i="1" dirty="0"/>
              <a:t>Yr9</a:t>
            </a:r>
            <a:r>
              <a:rPr lang="en-US" altLang="zh-CN" dirty="0"/>
              <a:t> functional markers in different materials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91F23B-D382-461C-997D-119821DB9798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182389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 S4. Marker for </a:t>
            </a:r>
            <a:r>
              <a:rPr lang="en-US" altLang="zh-CN" i="1" dirty="0"/>
              <a:t>QYrxz.nwafu-2BL.5</a:t>
            </a:r>
            <a:r>
              <a:rPr lang="en-US" altLang="zh-CN" dirty="0"/>
              <a:t>. Single marker analysis of KASP markers </a:t>
            </a:r>
            <a:r>
              <a:rPr lang="en-US" altLang="zh-CN" i="1" dirty="0"/>
              <a:t>IWB12298</a:t>
            </a:r>
            <a:r>
              <a:rPr lang="en-US" altLang="zh-CN" dirty="0"/>
              <a:t> in 366 Chinese lines/cultivars. </a:t>
            </a:r>
            <a:r>
              <a:rPr lang="en-US" altLang="zh-CN" i="1" dirty="0"/>
              <a:t>QYrxz.nwafu-2BL.5</a:t>
            </a:r>
            <a:r>
              <a:rPr lang="en-US" altLang="zh-CN" dirty="0"/>
              <a:t>+, accessions with </a:t>
            </a:r>
            <a:r>
              <a:rPr lang="en-US" altLang="zh-CN" i="1" dirty="0"/>
              <a:t>QYrxz.nwafu-2BL.5</a:t>
            </a:r>
            <a:r>
              <a:rPr lang="en-US" altLang="zh-CN" dirty="0"/>
              <a:t>; </a:t>
            </a:r>
            <a:r>
              <a:rPr lang="en-US" altLang="zh-CN" i="1" dirty="0"/>
              <a:t>QYrxz.nwafu-2BL.5-</a:t>
            </a:r>
            <a:r>
              <a:rPr lang="en-US" altLang="zh-CN" dirty="0"/>
              <a:t>,</a:t>
            </a:r>
            <a:r>
              <a:rPr lang="zh-CN" altLang="en-US" dirty="0"/>
              <a:t> </a:t>
            </a:r>
            <a:r>
              <a:rPr lang="en-US" altLang="zh-CN" dirty="0"/>
              <a:t>accessions lacking </a:t>
            </a:r>
            <a:r>
              <a:rPr lang="en-US" altLang="zh-CN" i="1" dirty="0"/>
              <a:t>QYrxz.nwafu-2BL.5</a:t>
            </a:r>
            <a:r>
              <a:rPr lang="en-US" altLang="zh-CN" dirty="0"/>
              <a:t>. Black, red and blue dots, representing NTC, HEX and FAM, respectively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91F23B-D382-461C-997D-119821DB9798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372476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dirty="0"/>
              <a:t>Fig S5. (a) V</a:t>
            </a:r>
            <a:r>
              <a:rPr lang="en-US" altLang="zh-CN" sz="1800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irus induced gene silencing (VIGS) test of the </a:t>
            </a:r>
            <a:r>
              <a:rPr lang="en-US" altLang="zh-CN" sz="1800" i="1" dirty="0" err="1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YrXZ</a:t>
            </a:r>
            <a:r>
              <a:rPr lang="en-US" altLang="zh-CN" sz="1800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gene on the </a:t>
            </a:r>
            <a:r>
              <a:rPr lang="en-US" altLang="zh-CN" sz="1800" kern="0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vocet+</a:t>
            </a:r>
            <a:r>
              <a:rPr lang="en-US" altLang="zh-CN" sz="1800" i="1" kern="0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Yr9</a:t>
            </a:r>
            <a:r>
              <a:rPr lang="en-US" altLang="zh-CN" sz="1800" kern="0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line</a:t>
            </a:r>
            <a:r>
              <a:rPr lang="en-US" altLang="zh-CN" sz="1800" dirty="0">
                <a:solidFill>
                  <a:srgbClr val="C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. </a:t>
            </a:r>
            <a:r>
              <a:rPr lang="en-US" altLang="zh-CN" dirty="0"/>
              <a:t>(b) After inoculation with CYR23, the biomass of </a:t>
            </a:r>
            <a:r>
              <a:rPr lang="en-US" altLang="zh-CN" i="1" dirty="0" err="1"/>
              <a:t>Pst</a:t>
            </a:r>
            <a:r>
              <a:rPr lang="en-US" altLang="zh-CN" dirty="0"/>
              <a:t> in the silenced leaves of </a:t>
            </a:r>
            <a:r>
              <a:rPr lang="en-US" altLang="zh-CN" i="1" dirty="0" err="1"/>
              <a:t>YrXZ</a:t>
            </a:r>
            <a:r>
              <a:rPr lang="en-US" altLang="zh-CN" dirty="0"/>
              <a:t> was measured by </a:t>
            </a:r>
            <a:r>
              <a:rPr lang="en-US" altLang="zh-CN" i="1" dirty="0" err="1"/>
              <a:t>PstEF</a:t>
            </a:r>
            <a:r>
              <a:rPr lang="en-US" altLang="zh-CN" dirty="0"/>
              <a:t> and </a:t>
            </a:r>
            <a:r>
              <a:rPr lang="en-US" altLang="zh-CN" i="1" dirty="0" err="1"/>
              <a:t>TaEF</a:t>
            </a:r>
            <a:r>
              <a:rPr lang="en-US" altLang="zh-CN" i="1" dirty="0"/>
              <a:t> </a:t>
            </a:r>
            <a:r>
              <a:rPr lang="en-US" altLang="zh-CN" dirty="0"/>
              <a:t>as internal reference genes. The values are presented as the mean ±SD (n=3). A t-test was employed for significance analysis (***P&lt;0.001).</a:t>
            </a: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91F23B-D382-461C-997D-119821DB9798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072149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800" dirty="0"/>
              <a:t>Fig S6.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Evolutionary tree between </a:t>
            </a:r>
            <a:r>
              <a:rPr lang="en-US" altLang="zh-CN" sz="18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Yr9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and cloned NLR genes in crops. 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91F23B-D382-461C-997D-119821DB9798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37692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EB04F0-5924-649F-8C4E-E1592AF4C2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FEA19BA-B57E-D11C-301D-4EBE27C3A5F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251DBD-D38F-0C3E-EBFB-C480CB051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2A40A6-73FA-0D19-34B6-BB1DC3C3AF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C11E559-9C70-8873-5203-B8A9854A0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5137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89A2CE-2D97-E108-70F4-3448CBCF4F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0CCEBFE-DDF6-3694-7CC5-67BA7F0E82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4C25EE-ACC0-403A-F6EE-DE41509A8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A85A54-D732-E87C-E729-4035DCD0D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EF1FB8-3509-6244-618B-6D88D90B8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8776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B4EB3E8-B6B3-EF14-4456-7A15A1E127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26B4C52-91A3-007B-61D5-891EEA3288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082F1F-739A-94C3-305A-15B1744B8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5E9B2D-ABD2-D0DB-0478-EE6761D31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D18FC7-C09D-08CB-4BA8-F36ED714D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1568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1CD2BA-6007-2BAD-18B5-32223BF53F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4E717C-3096-4AA3-4FEA-07101FB745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CEE413-7610-8731-66EA-719DD5A19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A24F3F-2E84-F6CB-C6FD-1B0338C42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37AA60-015E-3E57-9AAD-D2CED48F1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1512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7B6CFE-1220-C79F-8902-05A7DE69B6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D2AFC39-5DCB-73FA-0F4F-CF2B849158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83A6C4-9339-D87B-9FD6-CF97EA72C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E461DA-5BD2-4E67-16D2-A8BD33F78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AEEE82-CEAF-305F-D13D-7D2A733F9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9682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9A77CD-3FCD-936D-6E9C-A221917FA6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6B9A683-D6D9-E3EA-99B6-950B65B719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768D54A-CF21-E6EC-9B83-F52018E455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34B40F-B275-6E67-FBD0-1AE510D5A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6FBF61-490E-2371-BF46-78A8CB847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C519AB4-EC6D-B0E4-7262-293634653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5232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4B1AC2-9626-35D4-2646-6E0B8B643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FB6F227-67ED-DEB9-E8D7-95D645BFFD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1B74E00-2A39-1AB2-455A-50B97DD558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515F598-B0D7-B1FB-2EC0-E0DE45A639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4262E93-ADAF-920C-F1E2-6334F44E45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106A8EA-7741-264E-6407-9368D10D0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DA23CD2-92F6-478F-E028-BB2554F3C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26F7D5C-68B2-96D3-CB52-A5BF334A7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1933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07011A-4A86-96B3-51A8-2C61FAA02B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372E3D0-C053-5C59-376C-D104C9E9E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1C0289A-BA77-75B2-284C-0BBA68FEE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440B5AA-A56C-8087-4173-D66D9900C2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8528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94C1942-1314-D977-EC71-80D6DB92A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CEBBE3D-03A0-5813-54C0-2BF63E34B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D16F976-0A0C-807C-41C4-260E61131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8821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E84666-5CC6-8945-C552-4271E3FC16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4A464F1-299F-2517-C1BF-74B48F5E1B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5393B5A-DD7F-3A5F-8C6C-8D0EDA1DEC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50595B-3D59-11A4-838D-955D806BE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C6A22A-D087-A923-531B-0051BA5BF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722F7EE-0D8D-50AC-5FFC-030477079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59357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B7B171-37AB-2293-3294-A661E5A047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63DB2E0-9192-5FE7-C06D-137E88066B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DF08E1D-31C7-4F8B-69DB-D6341542F3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08E4548-60A0-AB5C-BBFE-EAE45F72F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84FAAA-D36E-C32B-4214-0B1C1BDB2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9163CB2-3A28-8321-E9DB-D28DB41D0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8255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50E18FC-D496-6B2D-7728-9EC5F8AF22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193B107-77B9-205A-B886-8B024E9858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AA2235-C26A-D087-8529-AE27608C66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0A9E70-A9F3-432A-B762-EB5310149F0A}" type="datetimeFigureOut">
              <a:rPr lang="zh-CN" altLang="en-US" smtClean="0"/>
              <a:t>2025/2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5C2F1B-49A4-5A78-AFDD-E4D974FE0B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6CE21B-3C3A-80EC-DD6E-DD63EB1C9F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FABB4-C16B-44E3-8754-697BA0A86D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264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microsoft.com/office/2014/relationships/chartEx" Target="../charts/chartEx1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2.png"/><Relationship Id="rId7" Type="http://schemas.microsoft.com/office/2007/relationships/hdphoto" Target="../media/hdphoto2.wdp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0" Type="http://schemas.openxmlformats.org/officeDocument/2006/relationships/image" Target="../media/image16.png"/><Relationship Id="rId4" Type="http://schemas.openxmlformats.org/officeDocument/2006/relationships/image" Target="../media/image13.png"/><Relationship Id="rId9" Type="http://schemas.microsoft.com/office/2007/relationships/hdphoto" Target="../media/hdphoto3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28013135-0D01-2729-F73E-D01A74CB91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7012" y="724806"/>
            <a:ext cx="5778729" cy="524151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05C1223-909C-F479-A208-44A690268B8F}"/>
              </a:ext>
            </a:extLst>
          </p:cNvPr>
          <p:cNvSpPr txBox="1"/>
          <p:nvPr/>
        </p:nvSpPr>
        <p:spPr>
          <a:xfrm>
            <a:off x="1290918" y="540140"/>
            <a:ext cx="9771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1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208437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>
            <a:extLst>
              <a:ext uri="{FF2B5EF4-FFF2-40B4-BE49-F238E27FC236}">
                <a16:creationId xmlns:a16="http://schemas.microsoft.com/office/drawing/2014/main" id="{8F39FF46-A900-D363-3634-ADC05C499A82}"/>
              </a:ext>
            </a:extLst>
          </p:cNvPr>
          <p:cNvGrpSpPr/>
          <p:nvPr/>
        </p:nvGrpSpPr>
        <p:grpSpPr>
          <a:xfrm>
            <a:off x="748037" y="1208644"/>
            <a:ext cx="5209524" cy="4314285"/>
            <a:chOff x="470131" y="832125"/>
            <a:chExt cx="5209524" cy="4314285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B9C87BD-521D-5DFD-9503-4B61E9A4AA3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3941" y="832125"/>
              <a:ext cx="5161905" cy="1428571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C46D9CDA-B92C-401E-4B38-18B078D8EF5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0131" y="2260696"/>
              <a:ext cx="5209524" cy="1457143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21873713-5D70-52FA-8D82-698EF9F4820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3941" y="3717839"/>
              <a:ext cx="5161905" cy="1428571"/>
            </a:xfrm>
            <a:prstGeom prst="rect">
              <a:avLst/>
            </a:prstGeom>
          </p:spPr>
        </p:pic>
      </p:grpSp>
      <p:pic>
        <p:nvPicPr>
          <p:cNvPr id="16" name="图片 15">
            <a:extLst>
              <a:ext uri="{FF2B5EF4-FFF2-40B4-BE49-F238E27FC236}">
                <a16:creationId xmlns:a16="http://schemas.microsoft.com/office/drawing/2014/main" id="{F8C469D8-54ED-3271-C891-5C442A641E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20153" y="1208644"/>
            <a:ext cx="5200000" cy="4371429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EA4F7DD0-E76B-FFD7-7E3E-EFC54E1E6751}"/>
              </a:ext>
            </a:extLst>
          </p:cNvPr>
          <p:cNvSpPr txBox="1"/>
          <p:nvPr/>
        </p:nvSpPr>
        <p:spPr>
          <a:xfrm>
            <a:off x="0" y="584963"/>
            <a:ext cx="9771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2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768362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655128C-2828-C7C8-110B-0119021F6D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7729" y="634340"/>
            <a:ext cx="5161905" cy="587619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8905617-9270-E560-9A9B-1593975253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13656" y="653387"/>
            <a:ext cx="5190476" cy="583809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1F4422BD-4304-71A3-F06C-91E22B2B1441}"/>
              </a:ext>
            </a:extLst>
          </p:cNvPr>
          <p:cNvSpPr txBox="1"/>
          <p:nvPr/>
        </p:nvSpPr>
        <p:spPr>
          <a:xfrm>
            <a:off x="0" y="325607"/>
            <a:ext cx="9771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2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711979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33B67F3-75DC-AC94-440D-E3D3723B66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1559" y="866767"/>
            <a:ext cx="5219048" cy="4371429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DBE81D56-AE4B-BCE3-2621-D90DBB3423DF}"/>
              </a:ext>
            </a:extLst>
          </p:cNvPr>
          <p:cNvSpPr txBox="1"/>
          <p:nvPr/>
        </p:nvSpPr>
        <p:spPr>
          <a:xfrm>
            <a:off x="0" y="497435"/>
            <a:ext cx="9771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2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404868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组合 25">
            <a:extLst>
              <a:ext uri="{FF2B5EF4-FFF2-40B4-BE49-F238E27FC236}">
                <a16:creationId xmlns:a16="http://schemas.microsoft.com/office/drawing/2014/main" id="{B3FD200F-57E9-E262-E27D-77B824695DED}"/>
              </a:ext>
            </a:extLst>
          </p:cNvPr>
          <p:cNvGrpSpPr/>
          <p:nvPr/>
        </p:nvGrpSpPr>
        <p:grpSpPr>
          <a:xfrm>
            <a:off x="1169894" y="907576"/>
            <a:ext cx="8754034" cy="3772299"/>
            <a:chOff x="1169894" y="907576"/>
            <a:chExt cx="8754034" cy="3772299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775326DD-EEB0-8997-12B8-323611A7DF81}"/>
                </a:ext>
              </a:extLst>
            </p:cNvPr>
            <p:cNvSpPr txBox="1"/>
            <p:nvPr/>
          </p:nvSpPr>
          <p:spPr>
            <a:xfrm>
              <a:off x="1169894" y="907576"/>
              <a:ext cx="97715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8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</a:rPr>
                <a:t>Fig S</a:t>
              </a:r>
              <a:r>
                <a:rPr lang="en-US" altLang="zh-CN" dirty="0">
                  <a:latin typeface="Times New Roman" panose="02020603050405020304" pitchFamily="18" charset="0"/>
                  <a:ea typeface="等线" panose="02010600030101010101" pitchFamily="2" charset="-122"/>
                </a:rPr>
                <a:t>3</a:t>
              </a:r>
              <a:r>
                <a:rPr lang="en-US" altLang="zh-CN" sz="18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</a:rPr>
                <a:t> </a:t>
              </a:r>
              <a:endParaRPr lang="zh-CN" altLang="en-US" dirty="0"/>
            </a:p>
          </p:txBody>
        </p: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980EFE7F-A1CB-A6C6-2CAE-AF6A07680A7B}"/>
                </a:ext>
              </a:extLst>
            </p:cNvPr>
            <p:cNvGrpSpPr/>
            <p:nvPr/>
          </p:nvGrpSpPr>
          <p:grpSpPr>
            <a:xfrm>
              <a:off x="2635622" y="1146146"/>
              <a:ext cx="7288306" cy="3533729"/>
              <a:chOff x="2572869" y="1316178"/>
              <a:chExt cx="7288306" cy="3533729"/>
            </a:xfrm>
          </p:grpSpPr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26BFCC2C-8111-7155-34AB-72AD35CB62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23" t="12419" r="10981" b="66405"/>
              <a:stretch/>
            </p:blipFill>
            <p:spPr>
              <a:xfrm>
                <a:off x="2572870" y="1577788"/>
                <a:ext cx="6418730" cy="1452283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19620FC2-7C8A-2734-4F6D-46C10E4F554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23" t="61830" r="10981" b="15164"/>
              <a:stretch/>
            </p:blipFill>
            <p:spPr>
              <a:xfrm>
                <a:off x="2572870" y="3272119"/>
                <a:ext cx="6418730" cy="1577788"/>
              </a:xfrm>
              <a:prstGeom prst="rect">
                <a:avLst/>
              </a:prstGeom>
            </p:spPr>
          </p:pic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B8F284EE-CC8E-8F25-B538-C1C836DEC127}"/>
                  </a:ext>
                </a:extLst>
              </p:cNvPr>
              <p:cNvSpPr txBox="1"/>
              <p:nvPr/>
            </p:nvSpPr>
            <p:spPr>
              <a:xfrm>
                <a:off x="2572870" y="1316178"/>
                <a:ext cx="32272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CAA8DBB0-DCC3-3CAE-9171-E88B39395A77}"/>
                  </a:ext>
                </a:extLst>
              </p:cNvPr>
              <p:cNvSpPr txBox="1"/>
              <p:nvPr/>
            </p:nvSpPr>
            <p:spPr>
              <a:xfrm>
                <a:off x="2572869" y="3010509"/>
                <a:ext cx="32272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" name="直接箭头连接符 10">
                <a:extLst>
                  <a:ext uri="{FF2B5EF4-FFF2-40B4-BE49-F238E27FC236}">
                    <a16:creationId xmlns:a16="http://schemas.microsoft.com/office/drawing/2014/main" id="{7BC3D4BF-80DC-D7C8-C29C-9099D1C19E1E}"/>
                  </a:ext>
                </a:extLst>
              </p:cNvPr>
              <p:cNvCxnSpPr/>
              <p:nvPr/>
            </p:nvCxnSpPr>
            <p:spPr>
              <a:xfrm flipH="1">
                <a:off x="8991600" y="3783106"/>
                <a:ext cx="224117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直接箭头连接符 11">
                <a:extLst>
                  <a:ext uri="{FF2B5EF4-FFF2-40B4-BE49-F238E27FC236}">
                    <a16:creationId xmlns:a16="http://schemas.microsoft.com/office/drawing/2014/main" id="{53F3D627-2653-C467-317E-6A448D59C788}"/>
                  </a:ext>
                </a:extLst>
              </p:cNvPr>
              <p:cNvCxnSpPr/>
              <p:nvPr/>
            </p:nvCxnSpPr>
            <p:spPr>
              <a:xfrm flipH="1">
                <a:off x="8991600" y="1918448"/>
                <a:ext cx="224117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0770F5ED-9205-2078-E7B1-57191A3BC83E}"/>
                  </a:ext>
                </a:extLst>
              </p:cNvPr>
              <p:cNvSpPr txBox="1"/>
              <p:nvPr/>
            </p:nvSpPr>
            <p:spPr>
              <a:xfrm>
                <a:off x="9215717" y="1787643"/>
                <a:ext cx="64545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r9-M1</a:t>
                </a:r>
                <a:endParaRPr lang="zh-CN" alt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A3C2BEFD-3059-3A30-5F0F-DF36025261CF}"/>
                  </a:ext>
                </a:extLst>
              </p:cNvPr>
              <p:cNvSpPr txBox="1"/>
              <p:nvPr/>
            </p:nvSpPr>
            <p:spPr>
              <a:xfrm>
                <a:off x="9215717" y="3652301"/>
                <a:ext cx="64545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r9-M1</a:t>
                </a:r>
                <a:endParaRPr lang="zh-CN" altLang="en-US" sz="11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7" name="直接箭头连接符 16">
              <a:extLst>
                <a:ext uri="{FF2B5EF4-FFF2-40B4-BE49-F238E27FC236}">
                  <a16:creationId xmlns:a16="http://schemas.microsoft.com/office/drawing/2014/main" id="{0D2822C8-5D7C-624A-01CC-8CC7F2200A9D}"/>
                </a:ext>
              </a:extLst>
            </p:cNvPr>
            <p:cNvCxnSpPr>
              <a:cxnSpLocks/>
            </p:cNvCxnSpPr>
            <p:nvPr/>
          </p:nvCxnSpPr>
          <p:spPr>
            <a:xfrm>
              <a:off x="2402541" y="3518129"/>
              <a:ext cx="23308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直接箭头连接符 18">
              <a:extLst>
                <a:ext uri="{FF2B5EF4-FFF2-40B4-BE49-F238E27FC236}">
                  <a16:creationId xmlns:a16="http://schemas.microsoft.com/office/drawing/2014/main" id="{D1513E4B-8800-A4E3-E80F-62DE9B0706B7}"/>
                </a:ext>
              </a:extLst>
            </p:cNvPr>
            <p:cNvCxnSpPr>
              <a:cxnSpLocks/>
            </p:cNvCxnSpPr>
            <p:nvPr/>
          </p:nvCxnSpPr>
          <p:spPr>
            <a:xfrm>
              <a:off x="2402543" y="3752844"/>
              <a:ext cx="23308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26043C2E-D753-361B-97E2-55514BA39C93}"/>
                </a:ext>
              </a:extLst>
            </p:cNvPr>
            <p:cNvSpPr txBox="1"/>
            <p:nvPr/>
          </p:nvSpPr>
          <p:spPr>
            <a:xfrm>
              <a:off x="1837765" y="3373877"/>
              <a:ext cx="6185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0bp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B0C960C0-D942-DE9D-C02C-85E45893F28A}"/>
                </a:ext>
              </a:extLst>
            </p:cNvPr>
            <p:cNvSpPr txBox="1"/>
            <p:nvPr/>
          </p:nvSpPr>
          <p:spPr>
            <a:xfrm>
              <a:off x="1837765" y="3614192"/>
              <a:ext cx="6185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bp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D028C408-E4F0-85E0-01BD-CEBA4FC36CDA}"/>
                </a:ext>
              </a:extLst>
            </p:cNvPr>
            <p:cNvSpPr txBox="1"/>
            <p:nvPr/>
          </p:nvSpPr>
          <p:spPr>
            <a:xfrm>
              <a:off x="1855695" y="1469464"/>
              <a:ext cx="6185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0bp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直接箭头连接符 22">
              <a:extLst>
                <a:ext uri="{FF2B5EF4-FFF2-40B4-BE49-F238E27FC236}">
                  <a16:creationId xmlns:a16="http://schemas.microsoft.com/office/drawing/2014/main" id="{37C0F006-D244-FE74-A25A-AD30C50A150C}"/>
                </a:ext>
              </a:extLst>
            </p:cNvPr>
            <p:cNvCxnSpPr>
              <a:cxnSpLocks/>
            </p:cNvCxnSpPr>
            <p:nvPr/>
          </p:nvCxnSpPr>
          <p:spPr>
            <a:xfrm>
              <a:off x="2402540" y="1630540"/>
              <a:ext cx="23308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接箭头连接符 23">
              <a:extLst>
                <a:ext uri="{FF2B5EF4-FFF2-40B4-BE49-F238E27FC236}">
                  <a16:creationId xmlns:a16="http://schemas.microsoft.com/office/drawing/2014/main" id="{FD68466D-70C9-721B-A318-F941E4F4CC78}"/>
                </a:ext>
              </a:extLst>
            </p:cNvPr>
            <p:cNvCxnSpPr>
              <a:cxnSpLocks/>
            </p:cNvCxnSpPr>
            <p:nvPr/>
          </p:nvCxnSpPr>
          <p:spPr>
            <a:xfrm>
              <a:off x="2402540" y="1879221"/>
              <a:ext cx="233081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46C81A9D-1613-91AC-21D6-13BAA185566A}"/>
                </a:ext>
              </a:extLst>
            </p:cNvPr>
            <p:cNvSpPr txBox="1"/>
            <p:nvPr/>
          </p:nvSpPr>
          <p:spPr>
            <a:xfrm>
              <a:off x="1855695" y="1746854"/>
              <a:ext cx="61856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bp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369107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1132F38E-5FA2-5718-F251-3EB0F15C2882}"/>
              </a:ext>
            </a:extLst>
          </p:cNvPr>
          <p:cNvGrpSpPr/>
          <p:nvPr/>
        </p:nvGrpSpPr>
        <p:grpSpPr>
          <a:xfrm>
            <a:off x="3207109" y="1861897"/>
            <a:ext cx="5841641" cy="3191115"/>
            <a:chOff x="3207109" y="1861897"/>
            <a:chExt cx="5841641" cy="3191115"/>
          </a:xfrm>
        </p:grpSpPr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43FFAB36-D286-AA17-1271-701CAC3785EB}"/>
                </a:ext>
              </a:extLst>
            </p:cNvPr>
            <p:cNvGrpSpPr/>
            <p:nvPr/>
          </p:nvGrpSpPr>
          <p:grpSpPr>
            <a:xfrm>
              <a:off x="3207109" y="2047875"/>
              <a:ext cx="5841641" cy="3005137"/>
              <a:chOff x="3207109" y="2047875"/>
              <a:chExt cx="5841641" cy="3005137"/>
            </a:xfrm>
          </p:grpSpPr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039CADB4-E8F7-52D1-B540-829A6DE1BC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71875" y="2231229"/>
                <a:ext cx="2524125" cy="2524125"/>
              </a:xfrm>
              <a:prstGeom prst="rect">
                <a:avLst/>
              </a:prstGeom>
            </p:spPr>
          </p:pic>
          <mc:AlternateContent xmlns:mc="http://schemas.openxmlformats.org/markup-compatibility/2006">
            <mc:Choice xmlns:cx1="http://schemas.microsoft.com/office/drawing/2015/9/8/chartex" Requires="cx1">
              <p:graphicFrame>
                <p:nvGraphicFramePr>
                  <p:cNvPr id="4" name="图表 3">
                    <a:extLst>
                      <a:ext uri="{FF2B5EF4-FFF2-40B4-BE49-F238E27FC236}">
                        <a16:creationId xmlns:a16="http://schemas.microsoft.com/office/drawing/2014/main" id="{57F1D85D-B75C-D634-E29C-AABCABE9D01C}"/>
                      </a:ext>
                    </a:extLst>
                  </p:cNvPr>
                  <p:cNvGraphicFramePr/>
                  <p:nvPr/>
                </p:nvGraphicFramePr>
                <p:xfrm>
                  <a:off x="6607967" y="2047875"/>
                  <a:ext cx="2440783" cy="3005137"/>
                </p:xfrm>
                <a:graphic>
                  <a:graphicData uri="http://schemas.microsoft.com/office/drawing/2014/chartex">
                    <cx:chart xmlns:cx="http://schemas.microsoft.com/office/drawing/2014/chartex" xmlns:r="http://schemas.openxmlformats.org/officeDocument/2006/relationships" r:id="rId4"/>
                  </a:graphicData>
                </a:graphic>
              </p:graphicFrame>
            </mc:Choice>
            <mc:Fallback>
              <p:pic>
                <p:nvPicPr>
                  <p:cNvPr id="4" name="图表 3">
                    <a:extLst>
                      <a:ext uri="{FF2B5EF4-FFF2-40B4-BE49-F238E27FC236}">
                        <a16:creationId xmlns:a16="http://schemas.microsoft.com/office/drawing/2014/main" id="{57F1D85D-B75C-D634-E29C-AABCABE9D01C}"/>
                      </a:ext>
                    </a:extLst>
                  </p:cNvPr>
                  <p:cNvPicPr>
                    <a:picLocks noGrp="1" noRot="1" noChangeAspect="1" noMove="1" noResize="1" noEditPoints="1" noAdjustHandles="1" noChangeArrowheads="1" noChangeShapeType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6607967" y="2047875"/>
                    <a:ext cx="2440783" cy="3005137"/>
                  </a:xfrm>
                  <a:prstGeom prst="rect">
                    <a:avLst/>
                  </a:prstGeom>
                </p:spPr>
              </p:pic>
            </mc:Fallback>
          </mc:AlternateContent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DF36F540-1328-47D9-D094-CFE53CC8A9D1}"/>
                  </a:ext>
                </a:extLst>
              </p:cNvPr>
              <p:cNvSpPr txBox="1"/>
              <p:nvPr/>
            </p:nvSpPr>
            <p:spPr>
              <a:xfrm rot="16200000">
                <a:off x="5941655" y="3330616"/>
                <a:ext cx="107870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sease severity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B7636310-74C0-E087-F328-ABBFEE3F4F77}"/>
                  </a:ext>
                </a:extLst>
              </p:cNvPr>
              <p:cNvSpPr txBox="1"/>
              <p:nvPr/>
            </p:nvSpPr>
            <p:spPr>
              <a:xfrm rot="16200000">
                <a:off x="3080088" y="3302042"/>
                <a:ext cx="50795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M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623B6E6C-9AC3-B319-8772-26E5173A98A1}"/>
                  </a:ext>
                </a:extLst>
              </p:cNvPr>
              <p:cNvSpPr txBox="1"/>
              <p:nvPr/>
            </p:nvSpPr>
            <p:spPr>
              <a:xfrm>
                <a:off x="4579958" y="4769641"/>
                <a:ext cx="50795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X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3B96DECF-1D90-B3AB-44D7-9DCCF614AD1A}"/>
                  </a:ext>
                </a:extLst>
              </p:cNvPr>
              <p:cNvSpPr txBox="1"/>
              <p:nvPr/>
            </p:nvSpPr>
            <p:spPr>
              <a:xfrm>
                <a:off x="4240191" y="2324100"/>
                <a:ext cx="84772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WB12298+</a:t>
                </a:r>
                <a:endParaRPr lang="zh-CN" altLang="en-US" sz="10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7EF05E42-A591-26A4-4758-495F29E0E69D}"/>
                  </a:ext>
                </a:extLst>
              </p:cNvPr>
              <p:cNvSpPr txBox="1"/>
              <p:nvPr/>
            </p:nvSpPr>
            <p:spPr>
              <a:xfrm>
                <a:off x="5112511" y="4143375"/>
                <a:ext cx="84772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WB12298-</a:t>
                </a:r>
                <a:endParaRPr lang="zh-CN" altLang="en-US" sz="105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580CE2B4-2D42-101C-5E20-50F88BE26E9C}"/>
                </a:ext>
              </a:extLst>
            </p:cNvPr>
            <p:cNvSpPr txBox="1"/>
            <p:nvPr/>
          </p:nvSpPr>
          <p:spPr>
            <a:xfrm>
              <a:off x="3207109" y="1861897"/>
              <a:ext cx="3317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E8E00A3-6762-59E2-647E-E58284E3B8C5}"/>
                </a:ext>
              </a:extLst>
            </p:cNvPr>
            <p:cNvSpPr txBox="1"/>
            <p:nvPr/>
          </p:nvSpPr>
          <p:spPr>
            <a:xfrm>
              <a:off x="6276207" y="1861897"/>
              <a:ext cx="3317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9A2AEF9E-66FE-6948-9F12-27B0D46BE579}"/>
              </a:ext>
            </a:extLst>
          </p:cNvPr>
          <p:cNvGrpSpPr/>
          <p:nvPr/>
        </p:nvGrpSpPr>
        <p:grpSpPr>
          <a:xfrm>
            <a:off x="7429500" y="1919605"/>
            <a:ext cx="1028700" cy="253916"/>
            <a:chOff x="7429500" y="1919605"/>
            <a:chExt cx="1028700" cy="253916"/>
          </a:xfrm>
        </p:grpSpPr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A83FA14D-0247-22F4-256F-79D69DE9961B}"/>
                </a:ext>
              </a:extLst>
            </p:cNvPr>
            <p:cNvSpPr txBox="1"/>
            <p:nvPr/>
          </p:nvSpPr>
          <p:spPr>
            <a:xfrm>
              <a:off x="7812501" y="1919605"/>
              <a:ext cx="41910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050" b="0" i="0" dirty="0">
                  <a:solidFill>
                    <a:srgbClr val="333333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zh-CN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id="{7382D019-8A76-8E7A-8CE9-642C99CFFEB2}"/>
                </a:ext>
              </a:extLst>
            </p:cNvPr>
            <p:cNvCxnSpPr/>
            <p:nvPr/>
          </p:nvCxnSpPr>
          <p:spPr>
            <a:xfrm>
              <a:off x="7429500" y="2112798"/>
              <a:ext cx="1028700" cy="0"/>
            </a:xfrm>
            <a:prstGeom prst="line">
              <a:avLst/>
            </a:prstGeom>
            <a:ln w="158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4F3C5BE9-B543-1F8F-11A6-5F1E96D5C48F}"/>
              </a:ext>
            </a:extLst>
          </p:cNvPr>
          <p:cNvSpPr txBox="1"/>
          <p:nvPr/>
        </p:nvSpPr>
        <p:spPr>
          <a:xfrm>
            <a:off x="1169894" y="907576"/>
            <a:ext cx="9771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4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23290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D87F1E2-EA93-3A6D-0348-A810C1977A5B}"/>
              </a:ext>
            </a:extLst>
          </p:cNvPr>
          <p:cNvSpPr txBox="1"/>
          <p:nvPr/>
        </p:nvSpPr>
        <p:spPr>
          <a:xfrm>
            <a:off x="1169894" y="907576"/>
            <a:ext cx="9771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</a:t>
            </a:r>
            <a:r>
              <a:rPr lang="en-US" altLang="zh-CN" dirty="0">
                <a:latin typeface="Times New Roman" panose="02020603050405020304" pitchFamily="18" charset="0"/>
                <a:ea typeface="等线" panose="02010600030101010101" pitchFamily="2" charset="-122"/>
              </a:rPr>
              <a:t>5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endParaRPr lang="zh-CN" altLang="en-US" dirty="0"/>
          </a:p>
        </p:txBody>
      </p: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69D95F5A-7855-F0C5-53CD-0FA22C6313AD}"/>
              </a:ext>
            </a:extLst>
          </p:cNvPr>
          <p:cNvGrpSpPr/>
          <p:nvPr/>
        </p:nvGrpSpPr>
        <p:grpSpPr>
          <a:xfrm>
            <a:off x="2280968" y="1166708"/>
            <a:ext cx="7425228" cy="4955350"/>
            <a:chOff x="2280968" y="1166708"/>
            <a:chExt cx="7425228" cy="4955350"/>
          </a:xfrm>
        </p:grpSpPr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08F11BCF-597C-5579-5580-F15836C0AFF1}"/>
                </a:ext>
              </a:extLst>
            </p:cNvPr>
            <p:cNvGrpSpPr/>
            <p:nvPr/>
          </p:nvGrpSpPr>
          <p:grpSpPr>
            <a:xfrm>
              <a:off x="6547258" y="2494971"/>
              <a:ext cx="3158938" cy="2363357"/>
              <a:chOff x="3718117" y="2138501"/>
              <a:chExt cx="3158938" cy="2363357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EB1061B3-5E4C-AC00-1DE0-3A2906C5F2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972033" y="2138501"/>
                <a:ext cx="1647717" cy="2109441"/>
              </a:xfrm>
              <a:prstGeom prst="rect">
                <a:avLst/>
              </a:prstGeom>
            </p:spPr>
          </p:pic>
          <p:grpSp>
            <p:nvGrpSpPr>
              <p:cNvPr id="13" name="组合 12">
                <a:extLst>
                  <a:ext uri="{FF2B5EF4-FFF2-40B4-BE49-F238E27FC236}">
                    <a16:creationId xmlns:a16="http://schemas.microsoft.com/office/drawing/2014/main" id="{EA599781-B0B2-DCD2-BF7C-9B534EF35DDD}"/>
                  </a:ext>
                </a:extLst>
              </p:cNvPr>
              <p:cNvGrpSpPr/>
              <p:nvPr/>
            </p:nvGrpSpPr>
            <p:grpSpPr>
              <a:xfrm>
                <a:off x="5810250" y="2138501"/>
                <a:ext cx="1066805" cy="701465"/>
                <a:chOff x="6448425" y="1917910"/>
                <a:chExt cx="1066805" cy="701465"/>
              </a:xfrm>
            </p:grpSpPr>
            <p:sp>
              <p:nvSpPr>
                <p:cNvPr id="6" name="矩形 5">
                  <a:extLst>
                    <a:ext uri="{FF2B5EF4-FFF2-40B4-BE49-F238E27FC236}">
                      <a16:creationId xmlns:a16="http://schemas.microsoft.com/office/drawing/2014/main" id="{F5C1D041-3BA4-8533-8B2A-1CA6F5DE88F1}"/>
                    </a:ext>
                  </a:extLst>
                </p:cNvPr>
                <p:cNvSpPr/>
                <p:nvPr/>
              </p:nvSpPr>
              <p:spPr>
                <a:xfrm>
                  <a:off x="6448425" y="2219325"/>
                  <a:ext cx="123827" cy="85725"/>
                </a:xfrm>
                <a:prstGeom prst="rect">
                  <a:avLst/>
                </a:prstGeom>
                <a:solidFill>
                  <a:srgbClr val="A0A0A4"/>
                </a:solidFill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7" name="矩形 6">
                  <a:extLst>
                    <a:ext uri="{FF2B5EF4-FFF2-40B4-BE49-F238E27FC236}">
                      <a16:creationId xmlns:a16="http://schemas.microsoft.com/office/drawing/2014/main" id="{7BE9D50E-AE68-CD50-48A3-F92A7CD45101}"/>
                    </a:ext>
                  </a:extLst>
                </p:cNvPr>
                <p:cNvSpPr/>
                <p:nvPr/>
              </p:nvSpPr>
              <p:spPr>
                <a:xfrm>
                  <a:off x="6448425" y="2438400"/>
                  <a:ext cx="123827" cy="85725"/>
                </a:xfrm>
                <a:prstGeom prst="rect">
                  <a:avLst/>
                </a:prstGeom>
                <a:solidFill>
                  <a:srgbClr val="80808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>
                    <a:shade val="15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" name="文本框 8">
                  <a:extLst>
                    <a:ext uri="{FF2B5EF4-FFF2-40B4-BE49-F238E27FC236}">
                      <a16:creationId xmlns:a16="http://schemas.microsoft.com/office/drawing/2014/main" id="{86819F4C-73E1-F31B-B6FE-AB5E57B06AFF}"/>
                    </a:ext>
                  </a:extLst>
                </p:cNvPr>
                <p:cNvSpPr txBox="1"/>
                <p:nvPr/>
              </p:nvSpPr>
              <p:spPr>
                <a:xfrm>
                  <a:off x="6572251" y="2138501"/>
                  <a:ext cx="933450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50" dirty="0"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</a:rPr>
                    <a:t>BSMV-γAS1</a:t>
                  </a:r>
                  <a:endParaRPr lang="zh-CN" altLang="en-US" sz="1050" dirty="0"/>
                </a:p>
              </p:txBody>
            </p:sp>
            <p:sp>
              <p:nvSpPr>
                <p:cNvPr id="10" name="文本框 9">
                  <a:extLst>
                    <a:ext uri="{FF2B5EF4-FFF2-40B4-BE49-F238E27FC236}">
                      <a16:creationId xmlns:a16="http://schemas.microsoft.com/office/drawing/2014/main" id="{29B83E16-9C8C-EE01-2C06-64BC2E611B02}"/>
                    </a:ext>
                  </a:extLst>
                </p:cNvPr>
                <p:cNvSpPr txBox="1"/>
                <p:nvPr/>
              </p:nvSpPr>
              <p:spPr>
                <a:xfrm>
                  <a:off x="6581780" y="2365459"/>
                  <a:ext cx="933450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50" dirty="0">
                      <a:effectLst/>
                      <a:latin typeface="Times New Roman" panose="02020603050405020304" pitchFamily="18" charset="0"/>
                      <a:ea typeface="等线" panose="02010600030101010101" pitchFamily="2" charset="-122"/>
                    </a:rPr>
                    <a:t>BSMV-γAS2</a:t>
                  </a:r>
                  <a:endParaRPr lang="zh-CN" altLang="en-US" sz="1050" dirty="0"/>
                </a:p>
              </p:txBody>
            </p:sp>
            <p:grpSp>
              <p:nvGrpSpPr>
                <p:cNvPr id="12" name="组合 11">
                  <a:extLst>
                    <a:ext uri="{FF2B5EF4-FFF2-40B4-BE49-F238E27FC236}">
                      <a16:creationId xmlns:a16="http://schemas.microsoft.com/office/drawing/2014/main" id="{050469B8-EBA1-7F78-1026-5363463C0B6C}"/>
                    </a:ext>
                  </a:extLst>
                </p:cNvPr>
                <p:cNvGrpSpPr/>
                <p:nvPr/>
              </p:nvGrpSpPr>
              <p:grpSpPr>
                <a:xfrm>
                  <a:off x="6448425" y="1917910"/>
                  <a:ext cx="1057281" cy="253916"/>
                  <a:chOff x="6448424" y="2582892"/>
                  <a:chExt cx="1057281" cy="253916"/>
                </a:xfrm>
              </p:grpSpPr>
              <p:sp>
                <p:nvSpPr>
                  <p:cNvPr id="8" name="矩形 7">
                    <a:extLst>
                      <a:ext uri="{FF2B5EF4-FFF2-40B4-BE49-F238E27FC236}">
                        <a16:creationId xmlns:a16="http://schemas.microsoft.com/office/drawing/2014/main" id="{B98BF23B-49F1-C8D1-E667-04029F727715}"/>
                      </a:ext>
                    </a:extLst>
                  </p:cNvPr>
                  <p:cNvSpPr/>
                  <p:nvPr/>
                </p:nvSpPr>
                <p:spPr>
                  <a:xfrm>
                    <a:off x="6448424" y="2657475"/>
                    <a:ext cx="123827" cy="85725"/>
                  </a:xfrm>
                  <a:prstGeom prst="rect">
                    <a:avLst/>
                  </a:prstGeom>
                </p:spPr>
                <p:style>
                  <a:lnRef idx="2">
                    <a:schemeClr val="dk1">
                      <a:shade val="15000"/>
                    </a:schemeClr>
                  </a:lnRef>
                  <a:fillRef idx="1">
                    <a:schemeClr val="dk1"/>
                  </a:fillRef>
                  <a:effectRef idx="0">
                    <a:schemeClr val="dk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/>
                  </a:p>
                </p:txBody>
              </p:sp>
              <p:sp>
                <p:nvSpPr>
                  <p:cNvPr id="11" name="文本框 10">
                    <a:extLst>
                      <a:ext uri="{FF2B5EF4-FFF2-40B4-BE49-F238E27FC236}">
                        <a16:creationId xmlns:a16="http://schemas.microsoft.com/office/drawing/2014/main" id="{6C1D893E-1AD7-0666-7FDC-A799C6D26A95}"/>
                      </a:ext>
                    </a:extLst>
                  </p:cNvPr>
                  <p:cNvSpPr txBox="1"/>
                  <p:nvPr/>
                </p:nvSpPr>
                <p:spPr>
                  <a:xfrm>
                    <a:off x="6572255" y="2582892"/>
                    <a:ext cx="933450" cy="2539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5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rPr>
                      <a:t>BSMV-γ</a:t>
                    </a:r>
                    <a:endParaRPr lang="zh-CN" altLang="en-US" sz="1050" dirty="0"/>
                  </a:p>
                </p:txBody>
              </p:sp>
            </p:grpSp>
          </p:grp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761F06D6-FDC6-9BA0-65E5-1B7DFBD65DFF}"/>
                  </a:ext>
                </a:extLst>
              </p:cNvPr>
              <p:cNvSpPr txBox="1"/>
              <p:nvPr/>
            </p:nvSpPr>
            <p:spPr>
              <a:xfrm rot="16200000">
                <a:off x="3083075" y="3074958"/>
                <a:ext cx="152400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st</a:t>
                </a:r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NA / Wheat DNA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2B461150-BC53-8796-F5E1-2F37AD656A26}"/>
                  </a:ext>
                </a:extLst>
              </p:cNvPr>
              <p:cNvSpPr txBox="1"/>
              <p:nvPr/>
            </p:nvSpPr>
            <p:spPr>
              <a:xfrm>
                <a:off x="4533900" y="4247942"/>
                <a:ext cx="847726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af s</a:t>
                </a:r>
                <a:r>
                  <a:rPr lang="en-US" altLang="zh-CN" sz="1050" i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mple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B41852A1-9AAF-2FDE-848D-AE7BB6875ACC}"/>
                </a:ext>
              </a:extLst>
            </p:cNvPr>
            <p:cNvGrpSpPr/>
            <p:nvPr/>
          </p:nvGrpSpPr>
          <p:grpSpPr>
            <a:xfrm>
              <a:off x="2717954" y="1282124"/>
              <a:ext cx="2054430" cy="4839934"/>
              <a:chOff x="2057427" y="655529"/>
              <a:chExt cx="2054430" cy="4839934"/>
            </a:xfrm>
          </p:grpSpPr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097D997F-0448-7474-6968-8E2F063975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057427" y="1709974"/>
                <a:ext cx="438095" cy="3780952"/>
              </a:xfrm>
              <a:prstGeom prst="rect">
                <a:avLst/>
              </a:prstGeom>
            </p:spPr>
          </p:pic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22C35CFC-F0D9-E358-84A6-5675188419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619291" y="1714511"/>
                <a:ext cx="419048" cy="3780952"/>
              </a:xfrm>
              <a:prstGeom prst="rect">
                <a:avLst/>
              </a:prstGeom>
            </p:spPr>
          </p:pic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DD449A65-5B75-CCF9-2A10-DB8F51C309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162108" y="1706840"/>
                <a:ext cx="419048" cy="3780952"/>
              </a:xfrm>
              <a:prstGeom prst="rect">
                <a:avLst/>
              </a:prstGeom>
            </p:spPr>
          </p:pic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728B241C-BB07-FC3A-39EF-69DF4DA77A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692808" y="1706840"/>
                <a:ext cx="419049" cy="3780952"/>
              </a:xfrm>
              <a:prstGeom prst="rect">
                <a:avLst/>
              </a:prstGeom>
            </p:spPr>
          </p:pic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A4836815-60CD-115B-596A-D6CAAA15560E}"/>
                  </a:ext>
                </a:extLst>
              </p:cNvPr>
              <p:cNvSpPr txBox="1"/>
              <p:nvPr/>
            </p:nvSpPr>
            <p:spPr>
              <a:xfrm rot="18840000">
                <a:off x="3072533" y="1270928"/>
                <a:ext cx="67624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SMV-γ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008C11F3-8A17-D848-05DB-177A8CB51D3F}"/>
                  </a:ext>
                </a:extLst>
              </p:cNvPr>
              <p:cNvSpPr txBox="1"/>
              <p:nvPr/>
            </p:nvSpPr>
            <p:spPr>
              <a:xfrm rot="18863247">
                <a:off x="1882301" y="1208239"/>
                <a:ext cx="906766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SMV-γAS1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F0EFD5DC-10AD-9FEE-243F-28829D90C7B2}"/>
                  </a:ext>
                </a:extLst>
              </p:cNvPr>
              <p:cNvSpPr txBox="1"/>
              <p:nvPr/>
            </p:nvSpPr>
            <p:spPr>
              <a:xfrm rot="18840000">
                <a:off x="2455586" y="1242352"/>
                <a:ext cx="93353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SMV-γAS2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AAA4C33C-7F06-48F8-884B-D565DACA6535}"/>
                  </a:ext>
                </a:extLst>
              </p:cNvPr>
              <p:cNvSpPr txBox="1"/>
              <p:nvPr/>
            </p:nvSpPr>
            <p:spPr>
              <a:xfrm rot="18840000">
                <a:off x="3466680" y="1208239"/>
                <a:ext cx="98929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SMV-</a:t>
                </a:r>
                <a:r>
                  <a:rPr lang="en-US" altLang="zh-CN" sz="105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γPDS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0C50A207-B657-B53F-D3E6-98B7EEE010B3}"/>
                  </a:ext>
                </a:extLst>
              </p:cNvPr>
              <p:cNvCxnSpPr/>
              <p:nvPr/>
            </p:nvCxnSpPr>
            <p:spPr>
              <a:xfrm>
                <a:off x="2057427" y="965804"/>
                <a:ext cx="2054430" cy="0"/>
              </a:xfrm>
              <a:prstGeom prst="line">
                <a:avLst/>
              </a:prstGeom>
              <a:ln w="158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A8463745-DCBD-E5D0-FD99-BC9F35196E4A}"/>
                  </a:ext>
                </a:extLst>
              </p:cNvPr>
              <p:cNvSpPr txBox="1"/>
              <p:nvPr/>
            </p:nvSpPr>
            <p:spPr>
              <a:xfrm>
                <a:off x="2815421" y="655529"/>
                <a:ext cx="603644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R23</a:t>
                </a:r>
                <a:endParaRPr lang="zh-CN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305298B2-8E85-4811-E631-BBA158D7C1CF}"/>
                </a:ext>
              </a:extLst>
            </p:cNvPr>
            <p:cNvSpPr txBox="1"/>
            <p:nvPr/>
          </p:nvSpPr>
          <p:spPr>
            <a:xfrm>
              <a:off x="2280968" y="1166708"/>
              <a:ext cx="3317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D2AACAA7-4525-7345-BF19-9CF43A11214F}"/>
                </a:ext>
              </a:extLst>
            </p:cNvPr>
            <p:cNvSpPr txBox="1"/>
            <p:nvPr/>
          </p:nvSpPr>
          <p:spPr>
            <a:xfrm>
              <a:off x="6215498" y="1202568"/>
              <a:ext cx="3317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993020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F91538DA-9075-11D7-9491-FD669153B2A6}"/>
              </a:ext>
            </a:extLst>
          </p:cNvPr>
          <p:cNvGrpSpPr/>
          <p:nvPr/>
        </p:nvGrpSpPr>
        <p:grpSpPr>
          <a:xfrm>
            <a:off x="2913764" y="0"/>
            <a:ext cx="4382386" cy="6858000"/>
            <a:chOff x="2913764" y="0"/>
            <a:chExt cx="4382386" cy="6858000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4E2C02F6-3220-0C73-EE7E-643B6C89F9A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13764" y="0"/>
              <a:ext cx="3659372" cy="6858000"/>
            </a:xfrm>
            <a:prstGeom prst="rect">
              <a:avLst/>
            </a:prstGeom>
          </p:spPr>
        </p:pic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9C825002-CE9A-3C4E-6EB0-C72DC635108E}"/>
                </a:ext>
              </a:extLst>
            </p:cNvPr>
            <p:cNvSpPr txBox="1"/>
            <p:nvPr/>
          </p:nvSpPr>
          <p:spPr>
            <a:xfrm>
              <a:off x="6487411" y="572735"/>
              <a:ext cx="808739" cy="62281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600"/>
                </a:lnSpc>
              </a:pP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3a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17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8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45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2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re3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r21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r13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r1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60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21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r5a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r7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46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r22a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rU1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5a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21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61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41a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m1a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26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13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22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r10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r10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35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50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r33</a:t>
              </a:r>
              <a:br>
                <a:rPr lang="pt-BR" altLang="zh-CN" sz="105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pt-BR" altLang="zh-CN" sz="1050" b="0" i="1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r9</a:t>
              </a:r>
              <a:endParaRPr lang="zh-CN" altLang="en-US" sz="105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文本框 5">
            <a:extLst>
              <a:ext uri="{FF2B5EF4-FFF2-40B4-BE49-F238E27FC236}">
                <a16:creationId xmlns:a16="http://schemas.microsoft.com/office/drawing/2014/main" id="{4D22C283-8897-5BB6-293F-5A7E567EFBDE}"/>
              </a:ext>
            </a:extLst>
          </p:cNvPr>
          <p:cNvSpPr txBox="1"/>
          <p:nvPr/>
        </p:nvSpPr>
        <p:spPr>
          <a:xfrm>
            <a:off x="1169894" y="907576"/>
            <a:ext cx="9771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 S6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52307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4</TotalTime>
  <Words>361</Words>
  <Application>Microsoft Office PowerPoint</Application>
  <PresentationFormat>宽屏</PresentationFormat>
  <Paragraphs>51</Paragraphs>
  <Slides>8</Slides>
  <Notes>7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7</cp:revision>
  <dcterms:created xsi:type="dcterms:W3CDTF">2024-12-24T11:17:03Z</dcterms:created>
  <dcterms:modified xsi:type="dcterms:W3CDTF">2025-02-16T18:36:11Z</dcterms:modified>
</cp:coreProperties>
</file>